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04T04:55:21.316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3199 0 24575,'-3132'0'-1365,"3066"0"-546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04T04:55:22.113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7 24575,'6'-6'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04T04:55:30.44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0 24575,'0'0'-8191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04T07:32:57.630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3199 0 24575,'-3132'0'-1365,"3066"0"-5461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04T07:48:06.79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3199 0 24575,'-3132'0'-1365,"3066"0"-5461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0-04T05:17:59.532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3199 0 24575,'-3132'0'-1365,"3066"0"-5461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28D294-EDDF-D842-7516-E12DA621DD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43076B-7994-EDBB-CB30-58C9E8546F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3D7627-7A74-567A-A9CA-422DD0935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C36686-4ECF-0F2C-460C-F0E0E5B51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5AF9B6-B2EB-D1C1-E2D5-B77A0E99C0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646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64B8F9-B70A-F3A3-01A9-DE2F130A7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2B4212-9586-E804-2C13-F66247870C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69B82-23BA-C7E3-A20D-613AB1758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E7D09-9F03-1E8A-3D87-D3BFCBF31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944261-C428-C56B-C4AD-023D8D07B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458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E8275A-DBAC-871A-55CD-A4DDE243CE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F5785A-61FF-CEFD-B128-2FD920EEED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40451-E45B-7C86-26D7-4F03BA653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F3F0A-B660-FE50-2CB9-8C532558B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0D537F-197F-518D-32F4-8556190A5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62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0BE568-CC92-DC22-3E87-C435E2F0B2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70BB0-31A6-FC1A-1211-7A525CBA63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B2C7DB-DAF9-5379-9BD9-7E062C218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5269EC-0C20-8B60-6599-75635270B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2F41FD-648E-C315-DB0D-7C3BD71D2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059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47A3F-D064-DD89-1509-C7904802B6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D4F359-2807-CEF8-FEBD-6BDD321DA9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3D42B-6BA8-78DA-22BA-596B936B9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76ACF8-63F3-5002-7F93-DDAB98814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1C2F8-8AF2-DA2A-E5CC-D0E786954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453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8AB8B-8C46-072C-9463-46DDC3DEA7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D57768-AFF6-D122-9DC3-89E7C4551D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A5A062-4B94-D1D4-4853-578240AB52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7204D9-F0F0-2CB2-674D-D1D25762B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59B9BF-74E7-F15C-85E7-1180F4457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D085E2-64C7-F8A8-FA1A-F733E50FD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77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F0791A-2423-8449-AD4E-01937DAD52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5CE0ED-C4AB-5074-85E1-05EE817658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69B2BD-471E-37D5-D2B1-66ECD30643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A8DC23-589D-FD5E-403C-EE43507953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354449-C72E-D6F8-7EEE-1D1281A771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C0CBF3-B3BE-1A2A-FF4E-12238C114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DD0127-1869-98E9-F51B-43C28A8E4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4C514F-F5E6-313E-6343-537C6A5A1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328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814F30-9A7D-E212-A456-8CD4B7B024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73377A-A6E7-3D52-F12B-DBC22D62B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14DB36-3305-464D-C2E3-2D8E7C420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CD7341F-6B95-00CA-72F5-271D95C88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027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400036-6458-3D8B-54EA-81B1AF369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CF988D-7CF0-E1CC-DCD9-1AEE86DE0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697272-8739-D9DE-41EC-C68858F94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261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C4CF6-33FE-F187-E9E1-4BF5B94DB4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575D0E-DC6D-AC95-6775-D28E1BE21F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197AA8-50A6-59B8-4749-D50C09A3C5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98AD66-822D-529C-8CFC-E8BF085DC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53F2FF-36B4-66F0-DA4C-905E9DD1D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19B7F4-B987-99C1-189C-3C1701068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384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5E49F1-AC51-E0A4-0F6A-AF749BF04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AEB0E9-290A-1E46-17F8-6596C4F65D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11567E-43DB-A112-6EDB-745E172D91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BEA3C4-C08B-F06A-39A1-CF59D2CCC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3F2601-840A-A540-6BAD-FB72E6868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5A359-2118-B4A8-BC83-33554EBC0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218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41FADD-8560-3234-5BC7-781F2AC451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41A289-1CB8-CD5A-BA60-6E262F530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5AC53-810B-8B9E-7C3D-5E2D867798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E8725-1176-407E-9776-AB0FF5EC2A62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7CB61C-C284-211A-36B0-9AAA494C4B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C81E91-5C7E-2572-35DD-324B468243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E7B78C-31F8-4775-8028-968D89BA9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552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ustomXml" Target="../ink/ink1.xml"/><Relationship Id="rId7" Type="http://schemas.openxmlformats.org/officeDocument/2006/relationships/customXml" Target="../ink/ink3.xml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customXml" Target="../ink/ink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ustomXml" Target="../ink/ink4.xm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ustomXml" Target="../ink/ink5.xml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ustomXml" Target="../ink/ink6.xml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3EC60E-5660-713F-9AFE-2F4FB0CF41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-497702" y="1852905"/>
            <a:ext cx="2001078" cy="857525"/>
          </a:xfrm>
        </p:spPr>
        <p:txBody>
          <a:bodyPr>
            <a:normAutofit/>
          </a:bodyPr>
          <a:lstStyle/>
          <a:p>
            <a:r>
              <a:rPr lang="en-US" sz="3200" dirty="0" err="1"/>
              <a:t>TrKB</a:t>
            </a:r>
            <a:endParaRPr lang="en-US" sz="32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09B9FE-8F1B-4153-CA53-6A50950ACFE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Content Placeholder 6">
            <a:extLst>
              <a:ext uri="{FF2B5EF4-FFF2-40B4-BE49-F238E27FC236}">
                <a16:creationId xmlns:a16="http://schemas.microsoft.com/office/drawing/2014/main" id="{E398D029-8F6E-E8C6-CFC5-E79C0BE1C2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209" y="999227"/>
            <a:ext cx="10035955" cy="4351338"/>
          </a:xfrm>
          <a:prstGeom prst="rect">
            <a:avLst/>
          </a:prstGeom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5" name="Ink 4">
                <a:extLst>
                  <a:ext uri="{FF2B5EF4-FFF2-40B4-BE49-F238E27FC236}">
                    <a16:creationId xmlns:a16="http://schemas.microsoft.com/office/drawing/2014/main" id="{568A6079-1644-EF27-4164-50644E0FB531}"/>
                  </a:ext>
                </a:extLst>
              </p14:cNvPr>
              <p14:cNvContentPartPr/>
              <p14:nvPr/>
            </p14:nvContentPartPr>
            <p14:xfrm>
              <a:off x="1114210" y="2530941"/>
              <a:ext cx="1151911" cy="360"/>
            </p14:xfrm>
          </p:contentPart>
        </mc:Choice>
        <mc:Fallback xmlns="">
          <p:pic>
            <p:nvPicPr>
              <p:cNvPr id="5" name="Ink 4">
                <a:extLst>
                  <a:ext uri="{FF2B5EF4-FFF2-40B4-BE49-F238E27FC236}">
                    <a16:creationId xmlns:a16="http://schemas.microsoft.com/office/drawing/2014/main" id="{568A6079-1644-EF27-4164-50644E0FB531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105208" y="2521941"/>
                <a:ext cx="1169555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6" name="Ink 5">
                <a:extLst>
                  <a:ext uri="{FF2B5EF4-FFF2-40B4-BE49-F238E27FC236}">
                    <a16:creationId xmlns:a16="http://schemas.microsoft.com/office/drawing/2014/main" id="{B149C9F6-0DD7-67F3-265C-055EC27E99D8}"/>
                  </a:ext>
                </a:extLst>
              </p14:cNvPr>
              <p14:cNvContentPartPr/>
              <p14:nvPr/>
            </p14:nvContentPartPr>
            <p14:xfrm>
              <a:off x="5671341" y="1971882"/>
              <a:ext cx="2520" cy="2520"/>
            </p14:xfrm>
          </p:contentPart>
        </mc:Choice>
        <mc:Fallback xmlns="">
          <p:pic>
            <p:nvPicPr>
              <p:cNvPr id="6" name="Ink 5">
                <a:extLst>
                  <a:ext uri="{FF2B5EF4-FFF2-40B4-BE49-F238E27FC236}">
                    <a16:creationId xmlns:a16="http://schemas.microsoft.com/office/drawing/2014/main" id="{B149C9F6-0DD7-67F3-265C-055EC27E99D8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662701" y="1963242"/>
                <a:ext cx="20160" cy="201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11" name="Ink 10">
                <a:extLst>
                  <a:ext uri="{FF2B5EF4-FFF2-40B4-BE49-F238E27FC236}">
                    <a16:creationId xmlns:a16="http://schemas.microsoft.com/office/drawing/2014/main" id="{61492CC5-6A3F-77FC-AD3A-F3A0AF2BBE2D}"/>
                  </a:ext>
                </a:extLst>
              </p14:cNvPr>
              <p14:cNvContentPartPr/>
              <p14:nvPr/>
            </p14:nvContentPartPr>
            <p14:xfrm>
              <a:off x="-835299" y="4796802"/>
              <a:ext cx="360" cy="360"/>
            </p14:xfrm>
          </p:contentPart>
        </mc:Choice>
        <mc:Fallback xmlns="">
          <p:pic>
            <p:nvPicPr>
              <p:cNvPr id="11" name="Ink 10">
                <a:extLst>
                  <a:ext uri="{FF2B5EF4-FFF2-40B4-BE49-F238E27FC236}">
                    <a16:creationId xmlns:a16="http://schemas.microsoft.com/office/drawing/2014/main" id="{61492CC5-6A3F-77FC-AD3A-F3A0AF2BBE2D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844299" y="4787802"/>
                <a:ext cx="18000" cy="18000"/>
              </a:xfrm>
              <a:prstGeom prst="rect">
                <a:avLst/>
              </a:prstGeom>
            </p:spPr>
          </p:pic>
        </mc:Fallback>
      </mc:AlternateContent>
      <p:sp>
        <p:nvSpPr>
          <p:cNvPr id="15" name="Text Box 8">
            <a:extLst>
              <a:ext uri="{FF2B5EF4-FFF2-40B4-BE49-F238E27FC236}">
                <a16:creationId xmlns:a16="http://schemas.microsoft.com/office/drawing/2014/main" id="{E21CA679-B09A-28CF-9E3D-A391D2F4D56C}"/>
              </a:ext>
            </a:extLst>
          </p:cNvPr>
          <p:cNvSpPr txBox="1"/>
          <p:nvPr/>
        </p:nvSpPr>
        <p:spPr>
          <a:xfrm rot="5400000">
            <a:off x="2562926" y="925656"/>
            <a:ext cx="680720" cy="34099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ntrol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17">
            <a:extLst>
              <a:ext uri="{FF2B5EF4-FFF2-40B4-BE49-F238E27FC236}">
                <a16:creationId xmlns:a16="http://schemas.microsoft.com/office/drawing/2014/main" id="{8733C393-ECD4-28A4-7FAB-406854FA3139}"/>
              </a:ext>
            </a:extLst>
          </p:cNvPr>
          <p:cNvSpPr txBox="1"/>
          <p:nvPr/>
        </p:nvSpPr>
        <p:spPr>
          <a:xfrm rot="5400000">
            <a:off x="3492914" y="987182"/>
            <a:ext cx="641985" cy="32956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MSO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18">
            <a:extLst>
              <a:ext uri="{FF2B5EF4-FFF2-40B4-BE49-F238E27FC236}">
                <a16:creationId xmlns:a16="http://schemas.microsoft.com/office/drawing/2014/main" id="{866B9412-9318-272A-AC43-6A8A70D06206}"/>
              </a:ext>
            </a:extLst>
          </p:cNvPr>
          <p:cNvSpPr txBox="1"/>
          <p:nvPr/>
        </p:nvSpPr>
        <p:spPr>
          <a:xfrm rot="5400000">
            <a:off x="4338500" y="925656"/>
            <a:ext cx="680720" cy="34099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otenone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19">
            <a:extLst>
              <a:ext uri="{FF2B5EF4-FFF2-40B4-BE49-F238E27FC236}">
                <a16:creationId xmlns:a16="http://schemas.microsoft.com/office/drawing/2014/main" id="{7629BFFF-A2FA-84C3-73EB-91EF835EBF40}"/>
              </a:ext>
            </a:extLst>
          </p:cNvPr>
          <p:cNvSpPr txBox="1"/>
          <p:nvPr/>
        </p:nvSpPr>
        <p:spPr>
          <a:xfrm rot="5400000">
            <a:off x="5344402" y="925656"/>
            <a:ext cx="680720" cy="34099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ricin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20">
            <a:extLst>
              <a:ext uri="{FF2B5EF4-FFF2-40B4-BE49-F238E27FC236}">
                <a16:creationId xmlns:a16="http://schemas.microsoft.com/office/drawing/2014/main" id="{A99F4682-A819-9675-C53D-FC5E1D6598BA}"/>
              </a:ext>
            </a:extLst>
          </p:cNvPr>
          <p:cNvSpPr txBox="1"/>
          <p:nvPr/>
        </p:nvSpPr>
        <p:spPr>
          <a:xfrm rot="5400000">
            <a:off x="6199747" y="800154"/>
            <a:ext cx="680720" cy="39814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otenone+siricin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8">
            <a:extLst>
              <a:ext uri="{FF2B5EF4-FFF2-40B4-BE49-F238E27FC236}">
                <a16:creationId xmlns:a16="http://schemas.microsoft.com/office/drawing/2014/main" id="{A79FEBFD-9DD1-FC4E-D995-3A49F07C92FB}"/>
              </a:ext>
            </a:extLst>
          </p:cNvPr>
          <p:cNvSpPr txBox="1"/>
          <p:nvPr/>
        </p:nvSpPr>
        <p:spPr>
          <a:xfrm rot="5400000">
            <a:off x="9833751" y="1094621"/>
            <a:ext cx="680720" cy="34099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ntrol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20">
            <a:extLst>
              <a:ext uri="{FF2B5EF4-FFF2-40B4-BE49-F238E27FC236}">
                <a16:creationId xmlns:a16="http://schemas.microsoft.com/office/drawing/2014/main" id="{33DB4478-CDBD-6401-FF58-B993024A8F86}"/>
              </a:ext>
            </a:extLst>
          </p:cNvPr>
          <p:cNvSpPr txBox="1"/>
          <p:nvPr/>
        </p:nvSpPr>
        <p:spPr>
          <a:xfrm rot="5400000">
            <a:off x="8895800" y="952891"/>
            <a:ext cx="680720" cy="39814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otenone+siricin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9">
            <a:extLst>
              <a:ext uri="{FF2B5EF4-FFF2-40B4-BE49-F238E27FC236}">
                <a16:creationId xmlns:a16="http://schemas.microsoft.com/office/drawing/2014/main" id="{1E9CDC68-81C4-FE9B-6BB2-D29445CC7616}"/>
              </a:ext>
            </a:extLst>
          </p:cNvPr>
          <p:cNvSpPr txBox="1"/>
          <p:nvPr/>
        </p:nvSpPr>
        <p:spPr>
          <a:xfrm rot="5400000">
            <a:off x="7958229" y="1081403"/>
            <a:ext cx="680720" cy="34099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ricin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18">
            <a:extLst>
              <a:ext uri="{FF2B5EF4-FFF2-40B4-BE49-F238E27FC236}">
                <a16:creationId xmlns:a16="http://schemas.microsoft.com/office/drawing/2014/main" id="{E9D0D18A-3769-14D1-2002-48CE8CDBC430}"/>
              </a:ext>
            </a:extLst>
          </p:cNvPr>
          <p:cNvSpPr txBox="1"/>
          <p:nvPr/>
        </p:nvSpPr>
        <p:spPr>
          <a:xfrm rot="5400000">
            <a:off x="7034679" y="925656"/>
            <a:ext cx="680720" cy="34099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otenone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228FA9-9175-AAE2-B8FC-A02C6B1EB397}"/>
              </a:ext>
            </a:extLst>
          </p:cNvPr>
          <p:cNvSpPr txBox="1"/>
          <p:nvPr/>
        </p:nvSpPr>
        <p:spPr>
          <a:xfrm>
            <a:off x="1410222" y="5732875"/>
            <a:ext cx="65372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rotein blot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rKB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6128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BF9F63-6C4E-B72D-0A03-20D7B6F9F8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107F4B-0962-4DA0-8C87-AE3F4B5D5B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236F303-B0CB-F8F3-DAF6-B90D093369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8337" y="1647825"/>
            <a:ext cx="8315325" cy="3562350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DDF51AE5-1D64-1211-65B9-BC87336E63C6}"/>
              </a:ext>
            </a:extLst>
          </p:cNvPr>
          <p:cNvSpPr txBox="1">
            <a:spLocks/>
          </p:cNvSpPr>
          <p:nvPr/>
        </p:nvSpPr>
        <p:spPr>
          <a:xfrm>
            <a:off x="762602" y="2115863"/>
            <a:ext cx="2001078" cy="857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/>
              <a:t>BDNF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6" name="Ink 5">
                <a:extLst>
                  <a:ext uri="{FF2B5EF4-FFF2-40B4-BE49-F238E27FC236}">
                    <a16:creationId xmlns:a16="http://schemas.microsoft.com/office/drawing/2014/main" id="{C8673D17-DBA3-9305-B591-77F0A9BE071C}"/>
                  </a:ext>
                </a:extLst>
              </p14:cNvPr>
              <p14:cNvContentPartPr/>
              <p14:nvPr/>
            </p14:nvContentPartPr>
            <p14:xfrm>
              <a:off x="1856332" y="2597202"/>
              <a:ext cx="1151911" cy="360"/>
            </p14:xfrm>
          </p:contentPart>
        </mc:Choice>
        <mc:Fallback xmlns="">
          <p:pic>
            <p:nvPicPr>
              <p:cNvPr id="6" name="Ink 5">
                <a:extLst>
                  <a:ext uri="{FF2B5EF4-FFF2-40B4-BE49-F238E27FC236}">
                    <a16:creationId xmlns:a16="http://schemas.microsoft.com/office/drawing/2014/main" id="{C8673D17-DBA3-9305-B591-77F0A9BE071C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847330" y="2588202"/>
                <a:ext cx="1169555" cy="18000"/>
              </a:xfrm>
              <a:prstGeom prst="rect">
                <a:avLst/>
              </a:prstGeom>
            </p:spPr>
          </p:pic>
        </mc:Fallback>
      </mc:AlternateContent>
      <p:sp>
        <p:nvSpPr>
          <p:cNvPr id="7" name="TextBox 6">
            <a:extLst>
              <a:ext uri="{FF2B5EF4-FFF2-40B4-BE49-F238E27FC236}">
                <a16:creationId xmlns:a16="http://schemas.microsoft.com/office/drawing/2014/main" id="{F5C971BE-0B56-D6A6-78DC-077B4F9C8541}"/>
              </a:ext>
            </a:extLst>
          </p:cNvPr>
          <p:cNvSpPr txBox="1"/>
          <p:nvPr/>
        </p:nvSpPr>
        <p:spPr>
          <a:xfrm>
            <a:off x="1410222" y="5732875"/>
            <a:ext cx="65372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rotein blot of BDNF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61540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4B0ED-6DD7-FC6F-2458-57966109B5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E9C92E44-85C0-409C-6CBB-A10532E289F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3320" y="2133566"/>
            <a:ext cx="7747000" cy="2171700"/>
          </a:xfr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61615B75-6964-8FE5-8303-BBB93802C67F}"/>
              </a:ext>
            </a:extLst>
          </p:cNvPr>
          <p:cNvSpPr txBox="1">
            <a:spLocks/>
          </p:cNvSpPr>
          <p:nvPr/>
        </p:nvSpPr>
        <p:spPr>
          <a:xfrm>
            <a:off x="1234611" y="3219416"/>
            <a:ext cx="2001078" cy="857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 err="1"/>
              <a:t>cfos</a:t>
            </a:r>
            <a:endParaRPr lang="en-US" sz="3200" dirty="0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7" name="Ink 6">
                <a:extLst>
                  <a:ext uri="{FF2B5EF4-FFF2-40B4-BE49-F238E27FC236}">
                    <a16:creationId xmlns:a16="http://schemas.microsoft.com/office/drawing/2014/main" id="{BD428742-BF42-3968-4AB8-4E3ACD095274}"/>
                  </a:ext>
                </a:extLst>
              </p14:cNvPr>
              <p14:cNvContentPartPr/>
              <p14:nvPr/>
            </p14:nvContentPartPr>
            <p14:xfrm>
              <a:off x="2148675" y="3724068"/>
              <a:ext cx="1151911" cy="360"/>
            </p14:xfrm>
          </p:contentPart>
        </mc:Choice>
        <mc:Fallback xmlns="">
          <p:pic>
            <p:nvPicPr>
              <p:cNvPr id="7" name="Ink 6">
                <a:extLst>
                  <a:ext uri="{FF2B5EF4-FFF2-40B4-BE49-F238E27FC236}">
                    <a16:creationId xmlns:a16="http://schemas.microsoft.com/office/drawing/2014/main" id="{BD428742-BF42-3968-4AB8-4E3ACD095274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139673" y="3715068"/>
                <a:ext cx="1169555" cy="18000"/>
              </a:xfrm>
              <a:prstGeom prst="rect">
                <a:avLst/>
              </a:prstGeom>
            </p:spPr>
          </p:pic>
        </mc:Fallback>
      </mc:AlternateContent>
      <p:sp>
        <p:nvSpPr>
          <p:cNvPr id="3" name="TextBox 2">
            <a:extLst>
              <a:ext uri="{FF2B5EF4-FFF2-40B4-BE49-F238E27FC236}">
                <a16:creationId xmlns:a16="http://schemas.microsoft.com/office/drawing/2014/main" id="{65B02246-36C7-5018-A9E8-61351E6B8C5A}"/>
              </a:ext>
            </a:extLst>
          </p:cNvPr>
          <p:cNvSpPr txBox="1"/>
          <p:nvPr/>
        </p:nvSpPr>
        <p:spPr>
          <a:xfrm>
            <a:off x="1410222" y="5732875"/>
            <a:ext cx="65372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3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rotein blot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fo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11989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4B48B1-CFE0-A424-31F1-DF3924695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E005B1DC-A100-2848-1052-FF480F877E5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7200" y="1948070"/>
            <a:ext cx="7344450" cy="3551824"/>
          </a:xfr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8ED72378-D4A1-50E3-B2E9-0F70456C857A}"/>
              </a:ext>
            </a:extLst>
          </p:cNvPr>
          <p:cNvSpPr txBox="1">
            <a:spLocks/>
          </p:cNvSpPr>
          <p:nvPr/>
        </p:nvSpPr>
        <p:spPr>
          <a:xfrm>
            <a:off x="630507" y="3400892"/>
            <a:ext cx="2001078" cy="857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l-GR" sz="3200" dirty="0"/>
              <a:t>β</a:t>
            </a:r>
            <a:r>
              <a:rPr lang="en-US" sz="3200" dirty="0"/>
              <a:t>-actin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7" name="Ink 6">
                <a:extLst>
                  <a:ext uri="{FF2B5EF4-FFF2-40B4-BE49-F238E27FC236}">
                    <a16:creationId xmlns:a16="http://schemas.microsoft.com/office/drawing/2014/main" id="{B610DAB8-E735-7DEF-88A3-31F211142BBB}"/>
                  </a:ext>
                </a:extLst>
              </p14:cNvPr>
              <p14:cNvContentPartPr/>
              <p14:nvPr/>
            </p14:nvContentPartPr>
            <p14:xfrm>
              <a:off x="1962350" y="3829655"/>
              <a:ext cx="1151911" cy="360"/>
            </p14:xfrm>
          </p:contentPart>
        </mc:Choice>
        <mc:Fallback xmlns="">
          <p:pic>
            <p:nvPicPr>
              <p:cNvPr id="7" name="Ink 6">
                <a:extLst>
                  <a:ext uri="{FF2B5EF4-FFF2-40B4-BE49-F238E27FC236}">
                    <a16:creationId xmlns:a16="http://schemas.microsoft.com/office/drawing/2014/main" id="{B610DAB8-E735-7DEF-88A3-31F211142BBB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53348" y="3820655"/>
                <a:ext cx="1169555" cy="18000"/>
              </a:xfrm>
              <a:prstGeom prst="rect">
                <a:avLst/>
              </a:prstGeom>
            </p:spPr>
          </p:pic>
        </mc:Fallback>
      </mc:AlternateContent>
      <p:sp>
        <p:nvSpPr>
          <p:cNvPr id="3" name="TextBox 2">
            <a:extLst>
              <a:ext uri="{FF2B5EF4-FFF2-40B4-BE49-F238E27FC236}">
                <a16:creationId xmlns:a16="http://schemas.microsoft.com/office/drawing/2014/main" id="{9AA89DCD-5FF7-E575-DBAA-563DD2036E40}"/>
              </a:ext>
            </a:extLst>
          </p:cNvPr>
          <p:cNvSpPr txBox="1"/>
          <p:nvPr/>
        </p:nvSpPr>
        <p:spPr>
          <a:xfrm>
            <a:off x="1410222" y="5732875"/>
            <a:ext cx="65372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4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rotein blot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beta-actin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4684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58</Words>
  <Application>Microsoft Office PowerPoint</Application>
  <PresentationFormat>Widescreen</PresentationFormat>
  <Paragraphs>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TrKB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H_ASHABI</dc:creator>
  <cp:lastModifiedBy>GH_ASHABI</cp:lastModifiedBy>
  <cp:revision>10</cp:revision>
  <dcterms:created xsi:type="dcterms:W3CDTF">2022-10-04T04:54:53Z</dcterms:created>
  <dcterms:modified xsi:type="dcterms:W3CDTF">2023-10-22T04:42:23Z</dcterms:modified>
</cp:coreProperties>
</file>